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  <p:sldId id="267" r:id="rId3"/>
    <p:sldId id="265" r:id="rId4"/>
    <p:sldId id="266" r:id="rId5"/>
    <p:sldId id="263" r:id="rId6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1881" autoAdjust="0"/>
    <p:restoredTop sz="94660"/>
  </p:normalViewPr>
  <p:slideViewPr>
    <p:cSldViewPr snapToGrid="0">
      <p:cViewPr varScale="1">
        <p:scale>
          <a:sx n="89" d="100"/>
          <a:sy n="89" d="100"/>
        </p:scale>
        <p:origin x="30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8347B-461A-4097-8E12-AC503B9443D3}" type="datetimeFigureOut">
              <a:rPr lang="en-US" smtClean="0"/>
              <a:t>3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BFAC9-27C8-4FFC-82AC-FB4C86079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727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8347B-461A-4097-8E12-AC503B9443D3}" type="datetimeFigureOut">
              <a:rPr lang="en-US" smtClean="0"/>
              <a:t>3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BFAC9-27C8-4FFC-82AC-FB4C86079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53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8347B-461A-4097-8E12-AC503B9443D3}" type="datetimeFigureOut">
              <a:rPr lang="en-US" smtClean="0"/>
              <a:t>3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BFAC9-27C8-4FFC-82AC-FB4C86079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365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8347B-461A-4097-8E12-AC503B9443D3}" type="datetimeFigureOut">
              <a:rPr lang="en-US" smtClean="0"/>
              <a:t>3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BFAC9-27C8-4FFC-82AC-FB4C86079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3390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8347B-461A-4097-8E12-AC503B9443D3}" type="datetimeFigureOut">
              <a:rPr lang="en-US" smtClean="0"/>
              <a:t>3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BFAC9-27C8-4FFC-82AC-FB4C86079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227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8347B-461A-4097-8E12-AC503B9443D3}" type="datetimeFigureOut">
              <a:rPr lang="en-US" smtClean="0"/>
              <a:t>3/2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BFAC9-27C8-4FFC-82AC-FB4C86079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5074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8347B-461A-4097-8E12-AC503B9443D3}" type="datetimeFigureOut">
              <a:rPr lang="en-US" smtClean="0"/>
              <a:t>3/2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BFAC9-27C8-4FFC-82AC-FB4C86079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7898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8347B-461A-4097-8E12-AC503B9443D3}" type="datetimeFigureOut">
              <a:rPr lang="en-US" smtClean="0"/>
              <a:t>3/2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BFAC9-27C8-4FFC-82AC-FB4C86079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554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8347B-461A-4097-8E12-AC503B9443D3}" type="datetimeFigureOut">
              <a:rPr lang="en-US" smtClean="0"/>
              <a:t>3/2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BFAC9-27C8-4FFC-82AC-FB4C86079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575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8347B-461A-4097-8E12-AC503B9443D3}" type="datetimeFigureOut">
              <a:rPr lang="en-US" smtClean="0"/>
              <a:t>3/2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BFAC9-27C8-4FFC-82AC-FB4C86079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2560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8347B-461A-4097-8E12-AC503B9443D3}" type="datetimeFigureOut">
              <a:rPr lang="en-US" smtClean="0"/>
              <a:t>3/2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BFAC9-27C8-4FFC-82AC-FB4C86079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72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98347B-461A-4097-8E12-AC503B9443D3}" type="datetimeFigureOut">
              <a:rPr lang="en-US" smtClean="0"/>
              <a:t>3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DBFAC9-27C8-4FFC-82AC-FB4C860794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270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11" Type="http://schemas.openxmlformats.org/officeDocument/2006/relationships/image" Target="../media/image25.png"/><Relationship Id="rId5" Type="http://schemas.openxmlformats.org/officeDocument/2006/relationships/image" Target="../media/image19.png"/><Relationship Id="rId10" Type="http://schemas.openxmlformats.org/officeDocument/2006/relationships/image" Target="../media/image24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png"/><Relationship Id="rId11" Type="http://schemas.openxmlformats.org/officeDocument/2006/relationships/image" Target="../media/image35.png"/><Relationship Id="rId5" Type="http://schemas.openxmlformats.org/officeDocument/2006/relationships/image" Target="../media/image29.png"/><Relationship Id="rId10" Type="http://schemas.openxmlformats.org/officeDocument/2006/relationships/image" Target="../media/image34.png"/><Relationship Id="rId4" Type="http://schemas.openxmlformats.org/officeDocument/2006/relationships/image" Target="../media/image28.png"/><Relationship Id="rId9" Type="http://schemas.openxmlformats.org/officeDocument/2006/relationships/image" Target="../media/image33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21017" y="381549"/>
            <a:ext cx="5661657" cy="8371452"/>
            <a:chOff x="296027" y="210510"/>
            <a:chExt cx="5661657" cy="8371452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96029" y="210510"/>
              <a:ext cx="2782671" cy="1588754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125809" y="288419"/>
              <a:ext cx="2783733" cy="1543803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6029" y="1832222"/>
              <a:ext cx="2733466" cy="1592101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125809" y="1812508"/>
              <a:ext cx="2735561" cy="1611815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20631" y="3529520"/>
              <a:ext cx="2733466" cy="1559143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199615" y="3424323"/>
              <a:ext cx="2758069" cy="1664340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08330" y="5154579"/>
              <a:ext cx="2758067" cy="1631382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078700" y="5154579"/>
              <a:ext cx="2830842" cy="1664689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96027" y="6779638"/>
              <a:ext cx="2733468" cy="1802324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114442" y="6779639"/>
              <a:ext cx="2715904" cy="1769886"/>
            </a:xfrm>
            <a:prstGeom prst="rect">
              <a:avLst/>
            </a:prstGeom>
          </p:spPr>
        </p:pic>
      </p:grpSp>
      <p:sp>
        <p:nvSpPr>
          <p:cNvPr id="21" name="TextBox 20"/>
          <p:cNvSpPr txBox="1"/>
          <p:nvPr/>
        </p:nvSpPr>
        <p:spPr>
          <a:xfrm>
            <a:off x="194553" y="8705671"/>
            <a:ext cx="666344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lecular characterization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rypanosom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pecies using nested PCR and Sanger sequencing targeting part of the tubulin gene cluster.  Gel images showing the trypanosome species identified in cattle tissues. M: Marker, B: blood, G: gonadal adipose, H: heart adipose , I: Intestine adipose, O: other adipose, SA: skin adipose, S: skin, Tb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: T. bruce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Tc: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. congolense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C: Negative Control (contains water instead of DNA)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xpected band sizes by nested PCR for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T. brucei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is 424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T. congolen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456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T.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vivax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586) and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T.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heileri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646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6433" y="71592"/>
            <a:ext cx="24643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Segoe UI Historic" panose="020B0502040204020203" pitchFamily="34" charset="0"/>
                <a:cs typeface="Arial" panose="020B0604020202020204" pitchFamily="34" charset="0"/>
              </a:rPr>
              <a:t>Additional file 1:  Fig. S1</a:t>
            </a:r>
          </a:p>
        </p:txBody>
      </p:sp>
    </p:spTree>
    <p:extLst>
      <p:ext uri="{BB962C8B-B14F-4D97-AF65-F5344CB8AC3E}">
        <p14:creationId xmlns:p14="http://schemas.microsoft.com/office/powerpoint/2010/main" val="30479508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24606" y="634487"/>
            <a:ext cx="5844626" cy="5164718"/>
            <a:chOff x="424606" y="634487"/>
            <a:chExt cx="5844626" cy="5164718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21560" y="634487"/>
              <a:ext cx="2475206" cy="1601763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68286" y="634487"/>
              <a:ext cx="2600946" cy="1648631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4606" y="2352724"/>
              <a:ext cx="2572160" cy="1713145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167804" y="2392491"/>
              <a:ext cx="2723669" cy="1784804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86595" y="4177295"/>
              <a:ext cx="2510171" cy="1621910"/>
            </a:xfrm>
            <a:prstGeom prst="rect">
              <a:avLst/>
            </a:prstGeom>
          </p:spPr>
        </p:pic>
      </p:grpSp>
      <p:sp>
        <p:nvSpPr>
          <p:cNvPr id="10" name="TextBox 9"/>
          <p:cNvSpPr txBox="1"/>
          <p:nvPr/>
        </p:nvSpPr>
        <p:spPr>
          <a:xfrm>
            <a:off x="135347" y="6108931"/>
            <a:ext cx="666344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lecular characterization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rypanosom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pecies using nested PCR and Sanger sequencing targeting part of the tubulin gene cluster.  Gel images showing the trypanosome species identified in sheep tissues. M: Marker, B: blood, G: gonadal adipose, H: heart adipose , I: Intestine adipose, O: other adipose, SA: skin adipose, S: skin, Tb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: T. bruce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Tc: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. congolense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C: Negative Control (contains water instead of DNA)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xpected band sizes by nested PCR for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T. brucei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is 424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T. congolen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456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T.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vivax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586) and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T.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heileri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646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9589" y="8223"/>
            <a:ext cx="24643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Segoe UI Historic" panose="020B0502040204020203" pitchFamily="34" charset="0"/>
                <a:cs typeface="Arial" panose="020B0604020202020204" pitchFamily="34" charset="0"/>
              </a:rPr>
              <a:t>Additional file 1:  Fig. S2</a:t>
            </a:r>
          </a:p>
        </p:txBody>
      </p:sp>
    </p:spTree>
    <p:extLst>
      <p:ext uri="{BB962C8B-B14F-4D97-AF65-F5344CB8AC3E}">
        <p14:creationId xmlns:p14="http://schemas.microsoft.com/office/powerpoint/2010/main" val="29427769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47807" y="84478"/>
            <a:ext cx="2640004" cy="1577070"/>
          </a:xfrm>
          <a:prstGeom prst="rect">
            <a:avLst/>
          </a:prstGeom>
        </p:spPr>
      </p:pic>
      <p:grpSp>
        <p:nvGrpSpPr>
          <p:cNvPr id="2" name="Group 1"/>
          <p:cNvGrpSpPr/>
          <p:nvPr/>
        </p:nvGrpSpPr>
        <p:grpSpPr>
          <a:xfrm>
            <a:off x="546427" y="218693"/>
            <a:ext cx="5498521" cy="8235388"/>
            <a:chOff x="368810" y="218599"/>
            <a:chExt cx="5498521" cy="8235388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76234" y="218599"/>
              <a:ext cx="2593956" cy="1528469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30187" y="1780867"/>
              <a:ext cx="2640003" cy="1605494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226721" y="1695253"/>
              <a:ext cx="2593955" cy="1686209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40670" y="3424033"/>
              <a:ext cx="2686051" cy="1586894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146560" y="3437998"/>
              <a:ext cx="2663633" cy="1586894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97389" y="5126727"/>
              <a:ext cx="2772801" cy="1586894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113052" y="5041054"/>
              <a:ext cx="2754279" cy="1649298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68810" y="6725266"/>
              <a:ext cx="2822768" cy="1728721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086696" y="6629823"/>
              <a:ext cx="2780635" cy="1786538"/>
            </a:xfrm>
            <a:prstGeom prst="rect">
              <a:avLst/>
            </a:prstGeom>
          </p:spPr>
        </p:pic>
      </p:grpSp>
      <p:sp>
        <p:nvSpPr>
          <p:cNvPr id="17" name="TextBox 16"/>
          <p:cNvSpPr txBox="1"/>
          <p:nvPr/>
        </p:nvSpPr>
        <p:spPr>
          <a:xfrm>
            <a:off x="194553" y="8549524"/>
            <a:ext cx="666344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lecular characterization of Trypanosoma species using nested PCR and Sanger sequencing targeting part of the tubulin gene cluster.  Gel images showing the trypanosome species identified in goats tissues. M: Marker, B: blood, G: gonadal adipose, H: heart adipose , I: Intestine adipose, O: other adipose, SA: skin adipose, S: skin, Tb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: T. bruce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Tc: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.congolense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C: Negative Control (contains water instead of DNA)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xpected band sizes by nested PCR for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T. brucei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is 424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T. congolen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456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T.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vivax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586) and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T.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heileri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646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69589" y="8223"/>
            <a:ext cx="24643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Segoe UI Historic" panose="020B0502040204020203" pitchFamily="34" charset="0"/>
                <a:cs typeface="Arial" panose="020B0604020202020204" pitchFamily="34" charset="0"/>
              </a:rPr>
              <a:t>Additional file 1:  Fig. S3</a:t>
            </a:r>
          </a:p>
        </p:txBody>
      </p:sp>
    </p:spTree>
    <p:extLst>
      <p:ext uri="{BB962C8B-B14F-4D97-AF65-F5344CB8AC3E}">
        <p14:creationId xmlns:p14="http://schemas.microsoft.com/office/powerpoint/2010/main" val="24773049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128769" y="8371953"/>
            <a:ext cx="6663447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lecular characterization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rypanosom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pecies using nested PCR and Sanger sequencing targeting part of the tubulin gene cluster.  Gel images showing the trypanosome species identified in goats tissues. M: Marker, B: blood, G: gonadal adipose, H: heart adipose , I: Intestine adipose, O: other adipose, SA: skin adipose, S: skin, Tb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: T. bruce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Tc: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. congolense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C: Negative Control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contains water instead of DNA).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xpected band sizes by nested PCR for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T. brucei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is 424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T. congolens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456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T.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vivax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586) and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T.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heileri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646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. The asterisks (*) indicates that the ‘Other adipose’ tissues were obtained from the kidney. All ‘Other adipose’ tissues were obtained from the stomach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69589" y="8223"/>
            <a:ext cx="24643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Segoe UI Historic" panose="020B0502040204020203" pitchFamily="34" charset="0"/>
                <a:cs typeface="Arial" panose="020B0604020202020204" pitchFamily="34" charset="0"/>
              </a:rPr>
              <a:t>Additional file 1:  Fig. S3</a:t>
            </a:r>
          </a:p>
        </p:txBody>
      </p:sp>
      <p:grpSp>
        <p:nvGrpSpPr>
          <p:cNvPr id="17" name="Group 16"/>
          <p:cNvGrpSpPr/>
          <p:nvPr/>
        </p:nvGrpSpPr>
        <p:grpSpPr>
          <a:xfrm>
            <a:off x="656826" y="31590"/>
            <a:ext cx="5533465" cy="8349318"/>
            <a:chOff x="406846" y="51321"/>
            <a:chExt cx="5717660" cy="8565400"/>
          </a:xfrm>
        </p:grpSpPr>
        <p:grpSp>
          <p:nvGrpSpPr>
            <p:cNvPr id="2" name="Group 1"/>
            <p:cNvGrpSpPr/>
            <p:nvPr/>
          </p:nvGrpSpPr>
          <p:grpSpPr>
            <a:xfrm>
              <a:off x="406846" y="51321"/>
              <a:ext cx="5717660" cy="8565400"/>
              <a:chOff x="341062" y="-55618"/>
              <a:chExt cx="5717660" cy="8565400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49142" y="49570"/>
                <a:ext cx="2554909" cy="1437531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324245" y="-55618"/>
                <a:ext cx="2645999" cy="1532524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54292" y="1641380"/>
                <a:ext cx="2619406" cy="1532524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324246" y="1602562"/>
                <a:ext cx="2639106" cy="1567580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316478" y="3299560"/>
                <a:ext cx="2646120" cy="1615093"/>
              </a:xfrm>
              <a:prstGeom prst="rect">
                <a:avLst/>
              </a:prstGeom>
            </p:spPr>
          </p:pic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58948" y="5110809"/>
                <a:ext cx="2586337" cy="1654771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41062" y="6799347"/>
                <a:ext cx="2687038" cy="1710435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157226" y="6747750"/>
                <a:ext cx="2901496" cy="1762032"/>
              </a:xfrm>
              <a:prstGeom prst="rect">
                <a:avLst/>
              </a:prstGeom>
            </p:spPr>
          </p:pic>
        </p:grpSp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06846" y="3339888"/>
              <a:ext cx="2816164" cy="1772660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437655" y="5088018"/>
              <a:ext cx="2598373" cy="173345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486257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5796425"/>
              </p:ext>
            </p:extLst>
          </p:nvPr>
        </p:nvGraphicFramePr>
        <p:xfrm>
          <a:off x="254097" y="1675147"/>
          <a:ext cx="6596634" cy="59317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85359">
                  <a:extLst>
                    <a:ext uri="{9D8B030D-6E8A-4147-A177-3AD203B41FA5}">
                      <a16:colId xmlns:a16="http://schemas.microsoft.com/office/drawing/2014/main" val="2900952815"/>
                    </a:ext>
                  </a:extLst>
                </a:gridCol>
                <a:gridCol w="1832488">
                  <a:extLst>
                    <a:ext uri="{9D8B030D-6E8A-4147-A177-3AD203B41FA5}">
                      <a16:colId xmlns:a16="http://schemas.microsoft.com/office/drawing/2014/main" val="3856287669"/>
                    </a:ext>
                  </a:extLst>
                </a:gridCol>
                <a:gridCol w="1903553">
                  <a:extLst>
                    <a:ext uri="{9D8B030D-6E8A-4147-A177-3AD203B41FA5}">
                      <a16:colId xmlns:a16="http://schemas.microsoft.com/office/drawing/2014/main" val="599419877"/>
                    </a:ext>
                  </a:extLst>
                </a:gridCol>
                <a:gridCol w="732817">
                  <a:extLst>
                    <a:ext uri="{9D8B030D-6E8A-4147-A177-3AD203B41FA5}">
                      <a16:colId xmlns:a16="http://schemas.microsoft.com/office/drawing/2014/main" val="420607185"/>
                    </a:ext>
                  </a:extLst>
                </a:gridCol>
                <a:gridCol w="804154">
                  <a:extLst>
                    <a:ext uri="{9D8B030D-6E8A-4147-A177-3AD203B41FA5}">
                      <a16:colId xmlns:a16="http://schemas.microsoft.com/office/drawing/2014/main" val="53577128"/>
                    </a:ext>
                  </a:extLst>
                </a:gridCol>
                <a:gridCol w="538263">
                  <a:extLst>
                    <a:ext uri="{9D8B030D-6E8A-4147-A177-3AD203B41FA5}">
                      <a16:colId xmlns:a16="http://schemas.microsoft.com/office/drawing/2014/main" val="2441822920"/>
                    </a:ext>
                  </a:extLst>
                </a:gridCol>
              </a:tblGrid>
              <a:tr h="14148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 ID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  identified via </a:t>
                      </a:r>
                    </a:p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sted PC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 identified </a:t>
                      </a:r>
                    </a:p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a sequencing 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quality</a:t>
                      </a:r>
                      <a:r>
                        <a:rPr lang="en-GB" sz="1200" b="1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efore trimming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similarity from</a:t>
                      </a:r>
                      <a:r>
                        <a:rPr lang="en-GB" sz="1200" b="1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LAST</a:t>
                      </a:r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es 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7147056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J (B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ir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837404170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J (B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congolense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congolense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ir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849936292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J (G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3151057341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J (SA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congolense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congolense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ir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2820912093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J (S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congolense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congolense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1079226617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8A (B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congolense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congolense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ir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3812280741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A (G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1293399793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8J (B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congolense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congolense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4245654029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8J (B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3300072795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A (B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vivax</a:t>
                      </a:r>
                      <a:r>
                        <a:rPr lang="en-GB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</a:p>
                    <a:p>
                      <a:pPr algn="l" fontAlgn="b"/>
                      <a:r>
                        <a:rPr lang="en-GB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 theiler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theiler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1307663015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A (SA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3435930484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3J (H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 congolense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congolense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ir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29173837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3J (H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4246468357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9A (B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vivax</a:t>
                      </a:r>
                      <a:r>
                        <a:rPr lang="en-GB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</a:p>
                    <a:p>
                      <a:pPr algn="l" fontAlgn="b"/>
                      <a:r>
                        <a:rPr lang="en-GB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</a:t>
                      </a:r>
                      <a:r>
                        <a:rPr lang="en-GB" sz="1200" i="1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heiler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congolense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s</a:t>
                      </a:r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match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ctr"/>
                </a:tc>
                <a:extLst>
                  <a:ext uri="{0D108BD9-81ED-4DB2-BD59-A6C34878D82A}">
                    <a16:rowId xmlns:a16="http://schemas.microsoft.com/office/drawing/2014/main" val="1168607434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5A(B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679652106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5A(G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773447574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4A (G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1317619707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4A (SA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2461015590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4J(G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7252683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4J(S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1514187742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5J(B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1033260417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5J(S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287669497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5(G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2682750641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6(B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ir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2251083626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6J(SA)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/>
                </a:tc>
                <a:extLst>
                  <a:ext uri="{0D108BD9-81ED-4DB2-BD59-A6C34878D82A}">
                    <a16:rowId xmlns:a16="http://schemas.microsoft.com/office/drawing/2014/main" val="1820245852"/>
                  </a:ext>
                </a:extLst>
              </a:tr>
              <a:tr h="141489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7J (G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anosoma_brucei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948" marR="2948" marT="2948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5427899"/>
                  </a:ext>
                </a:extLst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370729" y="1220749"/>
            <a:ext cx="250927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1: Table S1.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54097" y="7698622"/>
            <a:ext cx="57954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: blood, G: gonadal adipose, H: heart adipose , I: Intestine adipose, O: other adipose, SA: skin adipose, S: skin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12760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60</TotalTime>
  <Words>933</Words>
  <Application>Microsoft Macintosh PowerPoint</Application>
  <PresentationFormat>A4 Paper (210x297 mm)</PresentationFormat>
  <Paragraphs>15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malebna</dc:creator>
  <cp:lastModifiedBy>Theresa Manful Gwira</cp:lastModifiedBy>
  <cp:revision>108</cp:revision>
  <dcterms:created xsi:type="dcterms:W3CDTF">2023-04-29T09:34:52Z</dcterms:created>
  <dcterms:modified xsi:type="dcterms:W3CDTF">2024-03-28T11:58:01Z</dcterms:modified>
</cp:coreProperties>
</file>